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79" r:id="rId5"/>
    <p:sldId id="280" r:id="rId6"/>
    <p:sldId id="283" r:id="rId7"/>
    <p:sldId id="281" r:id="rId8"/>
    <p:sldId id="282" r:id="rId9"/>
    <p:sldId id="284" r:id="rId10"/>
    <p:sldId id="285" r:id="rId11"/>
    <p:sldId id="286" r:id="rId12"/>
    <p:sldId id="287" r:id="rId13"/>
    <p:sldId id="288" r:id="rId14"/>
    <p:sldId id="289" r:id="rId15"/>
    <p:sldId id="290" r:id="rId16"/>
    <p:sldId id="264" r:id="rId17"/>
  </p:sldIdLst>
  <p:sldSz cx="10799763" cy="14400213"/>
  <p:notesSz cx="6735763" cy="98694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2" autoAdjust="0"/>
    <p:restoredTop sz="94660"/>
  </p:normalViewPr>
  <p:slideViewPr>
    <p:cSldViewPr snapToGrid="0">
      <p:cViewPr varScale="1">
        <p:scale>
          <a:sx n="78" d="100"/>
          <a:sy n="78" d="100"/>
        </p:scale>
        <p:origin x="378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presProps" Target="presProps.xml"/><Relationship Id="rId3" Type="http://schemas.openxmlformats.org/officeDocument/2006/relationships/customXml" Target="../customXml/item3.xml"/><Relationship Id="rId21" Type="http://schemas.openxmlformats.org/officeDocument/2006/relationships/tableStyles" Target="tableStyle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10" Type="http://schemas.openxmlformats.org/officeDocument/2006/relationships/slide" Target="slides/slide6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2356703"/>
            <a:ext cx="9179799" cy="5013407"/>
          </a:xfrm>
        </p:spPr>
        <p:txBody>
          <a:bodyPr anchor="b"/>
          <a:lstStyle>
            <a:lvl1pPr algn="ctr">
              <a:defRPr sz="7087"/>
            </a:lvl1pPr>
          </a:lstStyle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1" y="7563446"/>
            <a:ext cx="8099822" cy="3476717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999" indent="0" algn="ctr">
              <a:buNone/>
              <a:defRPr sz="2362"/>
            </a:lvl2pPr>
            <a:lvl3pPr marL="1079998" indent="0" algn="ctr">
              <a:buNone/>
              <a:defRPr sz="2126"/>
            </a:lvl3pPr>
            <a:lvl4pPr marL="1619997" indent="0" algn="ctr">
              <a:buNone/>
              <a:defRPr sz="1890"/>
            </a:lvl4pPr>
            <a:lvl5pPr marL="2159996" indent="0" algn="ctr">
              <a:buNone/>
              <a:defRPr sz="1890"/>
            </a:lvl5pPr>
            <a:lvl6pPr marL="2699995" indent="0" algn="ctr">
              <a:buNone/>
              <a:defRPr sz="1890"/>
            </a:lvl6pPr>
            <a:lvl7pPr marL="3239994" indent="0" algn="ctr">
              <a:buNone/>
              <a:defRPr sz="1890"/>
            </a:lvl7pPr>
            <a:lvl8pPr marL="3779992" indent="0" algn="ctr">
              <a:buNone/>
              <a:defRPr sz="1890"/>
            </a:lvl8pPr>
            <a:lvl9pPr marL="4319991" indent="0" algn="ctr">
              <a:buNone/>
              <a:defRPr sz="1890"/>
            </a:lvl9pPr>
          </a:lstStyle>
          <a:p>
            <a:r>
              <a:rPr lang="en-US" altLang="ja-JP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5E43-380F-4F59-B94D-FB160E4644D3}" type="datetimeFigureOut">
              <a:rPr kumimoji="1" lang="ja-JP" altLang="en-US" smtClean="0"/>
              <a:t>2023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457C4-4A10-4C1E-B28F-88DD7B9E80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391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5E43-380F-4F59-B94D-FB160E4644D3}" type="datetimeFigureOut">
              <a:rPr kumimoji="1" lang="ja-JP" altLang="en-US" smtClean="0"/>
              <a:t>2023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457C4-4A10-4C1E-B28F-88DD7B9E80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37576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1" y="766678"/>
            <a:ext cx="2328699" cy="12203515"/>
          </a:xfrm>
        </p:spPr>
        <p:txBody>
          <a:bodyPr vert="eaVert"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766678"/>
            <a:ext cx="6851100" cy="12203515"/>
          </a:xfrm>
        </p:spPr>
        <p:txBody>
          <a:bodyPr vert="eaVert"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5E43-380F-4F59-B94D-FB160E4644D3}" type="datetimeFigureOut">
              <a:rPr kumimoji="1" lang="ja-JP" altLang="en-US" smtClean="0"/>
              <a:t>2023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457C4-4A10-4C1E-B28F-88DD7B9E80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44119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5E43-380F-4F59-B94D-FB160E4644D3}" type="datetimeFigureOut">
              <a:rPr kumimoji="1" lang="ja-JP" altLang="en-US" smtClean="0"/>
              <a:t>2023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457C4-4A10-4C1E-B28F-88DD7B9E80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58450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3590057"/>
            <a:ext cx="9314796" cy="5990088"/>
          </a:xfrm>
        </p:spPr>
        <p:txBody>
          <a:bodyPr anchor="b"/>
          <a:lstStyle>
            <a:lvl1pPr>
              <a:defRPr sz="7087"/>
            </a:lvl1pPr>
          </a:lstStyle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9636813"/>
            <a:ext cx="9314796" cy="3150046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/>
                </a:solidFill>
              </a:defRPr>
            </a:lvl1pPr>
            <a:lvl2pPr marL="539999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98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99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99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99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99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99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91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5E43-380F-4F59-B94D-FB160E4644D3}" type="datetimeFigureOut">
              <a:rPr kumimoji="1" lang="ja-JP" altLang="en-US" smtClean="0"/>
              <a:t>2023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457C4-4A10-4C1E-B28F-88DD7B9E80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5426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4" y="3833390"/>
            <a:ext cx="4589899" cy="9136803"/>
          </a:xfrm>
        </p:spPr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0" y="3833390"/>
            <a:ext cx="4589899" cy="9136803"/>
          </a:xfrm>
        </p:spPr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5E43-380F-4F59-B94D-FB160E4644D3}" type="datetimeFigureOut">
              <a:rPr kumimoji="1" lang="ja-JP" altLang="en-US" smtClean="0"/>
              <a:t>2023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457C4-4A10-4C1E-B28F-88DD7B9E80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8126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766681"/>
            <a:ext cx="9314796" cy="2783376"/>
          </a:xfrm>
        </p:spPr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3530053"/>
            <a:ext cx="4568805" cy="1730025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5260078"/>
            <a:ext cx="4568805" cy="7736782"/>
          </a:xfrm>
        </p:spPr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3530053"/>
            <a:ext cx="4591306" cy="1730025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5260078"/>
            <a:ext cx="4591306" cy="7736782"/>
          </a:xfrm>
        </p:spPr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5E43-380F-4F59-B94D-FB160E4644D3}" type="datetimeFigureOut">
              <a:rPr kumimoji="1" lang="ja-JP" altLang="en-US" smtClean="0"/>
              <a:t>2023/8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457C4-4A10-4C1E-B28F-88DD7B9E80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0823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5E43-380F-4F59-B94D-FB160E4644D3}" type="datetimeFigureOut">
              <a:rPr kumimoji="1" lang="ja-JP" altLang="en-US" smtClean="0"/>
              <a:t>2023/8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457C4-4A10-4C1E-B28F-88DD7B9E80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57392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5E43-380F-4F59-B94D-FB160E4644D3}" type="datetimeFigureOut">
              <a:rPr kumimoji="1" lang="ja-JP" altLang="en-US" smtClean="0"/>
              <a:t>2023/8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457C4-4A10-4C1E-B28F-88DD7B9E80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82622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960014"/>
            <a:ext cx="3483205" cy="3360050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2073367"/>
            <a:ext cx="5467380" cy="10233485"/>
          </a:xfrm>
        </p:spPr>
        <p:txBody>
          <a:bodyPr/>
          <a:lstStyle>
            <a:lvl1pPr>
              <a:defRPr sz="3780"/>
            </a:lvl1pPr>
            <a:lvl2pPr>
              <a:defRPr sz="3307"/>
            </a:lvl2pPr>
            <a:lvl3pPr>
              <a:defRPr sz="283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4320064"/>
            <a:ext cx="3483205" cy="8003453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5E43-380F-4F59-B94D-FB160E4644D3}" type="datetimeFigureOut">
              <a:rPr kumimoji="1" lang="ja-JP" altLang="en-US" smtClean="0"/>
              <a:t>2023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457C4-4A10-4C1E-B28F-88DD7B9E80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6461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960014"/>
            <a:ext cx="3483205" cy="3360050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2073367"/>
            <a:ext cx="5467380" cy="10233485"/>
          </a:xfrm>
        </p:spPr>
        <p:txBody>
          <a:bodyPr anchor="t"/>
          <a:lstStyle>
            <a:lvl1pPr marL="0" indent="0">
              <a:buNone/>
              <a:defRPr sz="3780"/>
            </a:lvl1pPr>
            <a:lvl2pPr marL="539999" indent="0">
              <a:buNone/>
              <a:defRPr sz="3307"/>
            </a:lvl2pPr>
            <a:lvl3pPr marL="1079998" indent="0">
              <a:buNone/>
              <a:defRPr sz="2835"/>
            </a:lvl3pPr>
            <a:lvl4pPr marL="1619997" indent="0">
              <a:buNone/>
              <a:defRPr sz="2362"/>
            </a:lvl4pPr>
            <a:lvl5pPr marL="2159996" indent="0">
              <a:buNone/>
              <a:defRPr sz="2362"/>
            </a:lvl5pPr>
            <a:lvl6pPr marL="2699995" indent="0">
              <a:buNone/>
              <a:defRPr sz="2362"/>
            </a:lvl6pPr>
            <a:lvl7pPr marL="3239994" indent="0">
              <a:buNone/>
              <a:defRPr sz="2362"/>
            </a:lvl7pPr>
            <a:lvl8pPr marL="3779992" indent="0">
              <a:buNone/>
              <a:defRPr sz="2362"/>
            </a:lvl8pPr>
            <a:lvl9pPr marL="4319991" indent="0">
              <a:buNone/>
              <a:defRPr sz="2362"/>
            </a:lvl9pPr>
          </a:lstStyle>
          <a:p>
            <a:r>
              <a:rPr lang="en-US" altLang="ja-JP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4320064"/>
            <a:ext cx="3483205" cy="8003453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845E43-380F-4F59-B94D-FB160E4644D3}" type="datetimeFigureOut">
              <a:rPr kumimoji="1" lang="ja-JP" altLang="en-US" smtClean="0"/>
              <a:t>2023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457C4-4A10-4C1E-B28F-88DD7B9E80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2441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484" y="766681"/>
            <a:ext cx="9314796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484" y="3833390"/>
            <a:ext cx="9314796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484" y="13346867"/>
            <a:ext cx="242994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845E43-380F-4F59-B94D-FB160E4644D3}" type="datetimeFigureOut">
              <a:rPr kumimoji="1" lang="ja-JP" altLang="en-US" smtClean="0"/>
              <a:t>2023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7422" y="13346867"/>
            <a:ext cx="364492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332" y="13346867"/>
            <a:ext cx="242994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0457C4-4A10-4C1E-B28F-88DD7B9E80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60525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79998" rtl="0" eaLnBrk="1" latinLnBrk="0" hangingPunct="1">
        <a:lnSpc>
          <a:spcPct val="90000"/>
        </a:lnSpc>
        <a:spcBef>
          <a:spcPct val="0"/>
        </a:spcBef>
        <a:buNone/>
        <a:defRPr kumimoji="1" sz="51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1079998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kumimoji="1"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98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49997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996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995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994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993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992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991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99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98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997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996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995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994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992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991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EFE160D-F38E-6B3C-0162-DD5514EFEF6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275" b="4783"/>
          <a:stretch/>
        </p:blipFill>
        <p:spPr>
          <a:xfrm>
            <a:off x="1703466" y="196132"/>
            <a:ext cx="7392830" cy="1277406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70791C0-116A-5B15-DDF9-FA13F006DDC3}"/>
              </a:ext>
            </a:extLst>
          </p:cNvPr>
          <p:cNvSpPr txBox="1"/>
          <p:nvPr/>
        </p:nvSpPr>
        <p:spPr>
          <a:xfrm>
            <a:off x="482857" y="13265475"/>
            <a:ext cx="963732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Supplementary Figure 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1</a:t>
            </a:r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: </a:t>
            </a:r>
            <a:r>
              <a:rPr lang="en-US" sz="2000" dirty="0">
                <a:latin typeface="Cambria" panose="02040503050406030204" pitchFamily="18" charset="0"/>
                <a:ea typeface="Cambria" panose="02040503050406030204" pitchFamily="18" charset="0"/>
              </a:rPr>
              <a:t>Forest plot showing meta-analysis of anti-HEV IgG prevalence by countries of 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Southeast Asia, with authors, years of study, and study population type. </a:t>
            </a:r>
            <a:endParaRPr lang="en-JP" sz="2000" dirty="0"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006002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B2DFD39-A7C6-94DA-99BD-EAE2AD31297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80" t="12060" r="-380" b="12596"/>
          <a:stretch/>
        </p:blipFill>
        <p:spPr>
          <a:xfrm>
            <a:off x="-5905" y="1413163"/>
            <a:ext cx="10805668" cy="976970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7438CDD-36A2-20B3-B707-121645BF1A25}"/>
              </a:ext>
            </a:extLst>
          </p:cNvPr>
          <p:cNvSpPr txBox="1"/>
          <p:nvPr/>
        </p:nvSpPr>
        <p:spPr>
          <a:xfrm>
            <a:off x="399590" y="11848277"/>
            <a:ext cx="1010365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Supplementary Figure 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10</a:t>
            </a:r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: </a:t>
            </a:r>
            <a:r>
              <a:rPr lang="en-US" sz="2000" dirty="0">
                <a:latin typeface="Cambria" panose="02040503050406030204" pitchFamily="18" charset="0"/>
                <a:ea typeface="Cambria" panose="02040503050406030204" pitchFamily="18" charset="0"/>
              </a:rPr>
              <a:t>Forest plot showing meta-analysis of anti-HEV IgM prevalence divided by decades among the study population 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of Southeast Asia.</a:t>
            </a:r>
          </a:p>
          <a:p>
            <a:r>
              <a:rPr lang="en-GB" sz="1400" dirty="0">
                <a:latin typeface="Cambria" panose="02040503050406030204" pitchFamily="18" charset="0"/>
                <a:ea typeface="Cambria" panose="02040503050406030204" pitchFamily="18" charset="0"/>
              </a:rPr>
              <a:t>n/a – studies which does not include the study period information</a:t>
            </a:r>
            <a:endParaRPr lang="en-JP" sz="1400" dirty="0"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138082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6B88BBD-3B63-0203-2ED7-7F19210A3B7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9480" b="30061"/>
          <a:stretch/>
        </p:blipFill>
        <p:spPr>
          <a:xfrm>
            <a:off x="8519" y="2920314"/>
            <a:ext cx="10791244" cy="524750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435B97F-2E2C-CF79-D580-E8E0C569E227}"/>
              </a:ext>
            </a:extLst>
          </p:cNvPr>
          <p:cNvSpPr txBox="1"/>
          <p:nvPr/>
        </p:nvSpPr>
        <p:spPr>
          <a:xfrm>
            <a:off x="499271" y="8809494"/>
            <a:ext cx="976919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Supplementary Figure 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11</a:t>
            </a:r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: </a:t>
            </a:r>
            <a:r>
              <a:rPr lang="en-US" sz="2000" dirty="0">
                <a:latin typeface="Cambria" panose="02040503050406030204" pitchFamily="18" charset="0"/>
                <a:ea typeface="Cambria" panose="02040503050406030204" pitchFamily="18" charset="0"/>
              </a:rPr>
              <a:t>Forest plot showing meta-analysis of anti-HEV IgM prevalence divided by decades among the high-risk of acquiring HEV population o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f Southeast Asia.</a:t>
            </a:r>
          </a:p>
          <a:p>
            <a:r>
              <a:rPr lang="en-GB" sz="1400" dirty="0">
                <a:latin typeface="Cambria" panose="02040503050406030204" pitchFamily="18" charset="0"/>
                <a:ea typeface="Cambria" panose="02040503050406030204" pitchFamily="18" charset="0"/>
              </a:rPr>
              <a:t>n/a – studies which does not include the study period information</a:t>
            </a:r>
            <a:endParaRPr lang="en-JP" sz="1400" dirty="0"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555995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C34279C-391F-B8E5-4534-CD44680C79E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8780" b="19816"/>
          <a:stretch/>
        </p:blipFill>
        <p:spPr>
          <a:xfrm>
            <a:off x="0" y="2522753"/>
            <a:ext cx="10830957" cy="801756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3D39A8F-29E9-9BF3-46C9-4B7E1F1FD360}"/>
              </a:ext>
            </a:extLst>
          </p:cNvPr>
          <p:cNvSpPr txBox="1"/>
          <p:nvPr/>
        </p:nvSpPr>
        <p:spPr>
          <a:xfrm>
            <a:off x="404038" y="10888175"/>
            <a:ext cx="100003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Supplementary Figure 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12</a:t>
            </a:r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: </a:t>
            </a:r>
            <a:r>
              <a:rPr lang="en-US" sz="2000" dirty="0">
                <a:latin typeface="Cambria" panose="02040503050406030204" pitchFamily="18" charset="0"/>
                <a:ea typeface="Cambria" panose="02040503050406030204" pitchFamily="18" charset="0"/>
              </a:rPr>
              <a:t>Forest plot showing meta-analysis of anti-HEV IgM prevalence divided by decades among the low-risk of acquiring HEV population o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f Southeast Asia.</a:t>
            </a:r>
          </a:p>
          <a:p>
            <a:r>
              <a:rPr lang="en-GB" sz="1400" dirty="0">
                <a:latin typeface="Cambria" panose="02040503050406030204" pitchFamily="18" charset="0"/>
                <a:ea typeface="Cambria" panose="02040503050406030204" pitchFamily="18" charset="0"/>
              </a:rPr>
              <a:t>n/a – studies which does not include the study period information</a:t>
            </a:r>
            <a:endParaRPr lang="en-JP" sz="1400" dirty="0"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723485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55E0C68-4E92-D059-6BFB-D70D6E63B6D8}"/>
              </a:ext>
            </a:extLst>
          </p:cNvPr>
          <p:cNvSpPr txBox="1"/>
          <p:nvPr/>
        </p:nvSpPr>
        <p:spPr>
          <a:xfrm>
            <a:off x="741405" y="7512519"/>
            <a:ext cx="94379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Supplementary Figure 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13</a:t>
            </a:r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: </a:t>
            </a:r>
            <a:r>
              <a:rPr lang="en-US" sz="2000" dirty="0">
                <a:latin typeface="Cambria" panose="02040503050406030204" pitchFamily="18" charset="0"/>
                <a:ea typeface="Cambria" panose="02040503050406030204" pitchFamily="18" charset="0"/>
              </a:rPr>
              <a:t>Forest plot showing meta-analysis of anti-HEV total Ig prevalence in the outbreak settings 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in Southeast Asia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AE9C0A4-1DCB-8D2F-825B-23B507F1B51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04" t="28357" r="17126" b="27942"/>
          <a:stretch/>
        </p:blipFill>
        <p:spPr>
          <a:xfrm>
            <a:off x="620394" y="4031958"/>
            <a:ext cx="9558974" cy="33800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23049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CFC5C15-3BCD-D2C6-3FDD-AB36CD16EA5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553" t="2993" r="6624" b="3507"/>
          <a:stretch/>
        </p:blipFill>
        <p:spPr>
          <a:xfrm>
            <a:off x="1983056" y="0"/>
            <a:ext cx="6833649" cy="1324644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A8668B6-E113-24E6-FB34-EB6F5A97A3A6}"/>
              </a:ext>
            </a:extLst>
          </p:cNvPr>
          <p:cNvSpPr txBox="1"/>
          <p:nvPr/>
        </p:nvSpPr>
        <p:spPr>
          <a:xfrm>
            <a:off x="1039778" y="13380522"/>
            <a:ext cx="913660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Supplementary Figure 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2</a:t>
            </a:r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: 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F</a:t>
            </a:r>
            <a:r>
              <a:rPr lang="en-US" sz="2000" dirty="0">
                <a:latin typeface="Cambria" panose="02040503050406030204" pitchFamily="18" charset="0"/>
                <a:ea typeface="Cambria" panose="02040503050406030204" pitchFamily="18" charset="0"/>
              </a:rPr>
              <a:t>orest plot showing meta-analysis of anti-HEV IgG prevalence by the 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study population in Southeast Asia.</a:t>
            </a:r>
            <a:endParaRPr lang="en-JP" sz="2000" dirty="0"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53091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E21B125-8B41-97DC-821C-021E27F9CC6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246"/>
          <a:stretch/>
        </p:blipFill>
        <p:spPr>
          <a:xfrm>
            <a:off x="263594" y="0"/>
            <a:ext cx="10029584" cy="1320624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EC9FB0E-EA72-6E50-F38F-06D729678779}"/>
              </a:ext>
            </a:extLst>
          </p:cNvPr>
          <p:cNvSpPr txBox="1"/>
          <p:nvPr/>
        </p:nvSpPr>
        <p:spPr>
          <a:xfrm>
            <a:off x="636372" y="13345350"/>
            <a:ext cx="9656805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JP" altLang="ja-JP" sz="2000" dirty="0">
                <a:latin typeface="Cambria" panose="02040503050406030204" pitchFamily="18" charset="0"/>
                <a:ea typeface="Cambria" panose="02040503050406030204" pitchFamily="18" charset="0"/>
              </a:rPr>
              <a:t>Supplementary Figure </a:t>
            </a:r>
            <a:r>
              <a:rPr lang="en-GB" altLang="ja-JP" sz="2000" dirty="0">
                <a:latin typeface="Cambria" panose="02040503050406030204" pitchFamily="18" charset="0"/>
                <a:ea typeface="Cambria" panose="02040503050406030204" pitchFamily="18" charset="0"/>
              </a:rPr>
              <a:t>3</a:t>
            </a:r>
            <a:r>
              <a:rPr lang="en-JP" altLang="ja-JP" sz="2000" dirty="0">
                <a:latin typeface="Cambria" panose="02040503050406030204" pitchFamily="18" charset="0"/>
                <a:ea typeface="Cambria" panose="02040503050406030204" pitchFamily="18" charset="0"/>
              </a:rPr>
              <a:t>: </a:t>
            </a:r>
            <a:r>
              <a:rPr lang="en-US" altLang="ja-JP" sz="2000" dirty="0">
                <a:latin typeface="Cambria" panose="02040503050406030204" pitchFamily="18" charset="0"/>
                <a:ea typeface="Cambria" panose="02040503050406030204" pitchFamily="18" charset="0"/>
              </a:rPr>
              <a:t>Forest plot showing meta-analysis of anti-HEV IgG prevalence divided by decades among the study population </a:t>
            </a:r>
            <a:r>
              <a:rPr lang="en-GB" altLang="ja-JP" sz="2000" dirty="0">
                <a:latin typeface="Cambria" panose="02040503050406030204" pitchFamily="18" charset="0"/>
                <a:ea typeface="Cambria" panose="02040503050406030204" pitchFamily="18" charset="0"/>
              </a:rPr>
              <a:t>of Southeast Asia.</a:t>
            </a:r>
          </a:p>
          <a:p>
            <a:r>
              <a:rPr lang="en-GB" altLang="ja-JP" sz="1400" dirty="0">
                <a:latin typeface="Cambria" panose="02040503050406030204" pitchFamily="18" charset="0"/>
                <a:ea typeface="Cambria" panose="02040503050406030204" pitchFamily="18" charset="0"/>
              </a:rPr>
              <a:t>n/a – studies which does not include the study period information</a:t>
            </a:r>
            <a:endParaRPr lang="en-JP" altLang="ja-JP" sz="1400" dirty="0"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97898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BE1B8CB-12CB-0E0D-F528-C8E28A60121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697" t="12830" r="8244" b="13359"/>
          <a:stretch/>
        </p:blipFill>
        <p:spPr>
          <a:xfrm>
            <a:off x="0" y="161928"/>
            <a:ext cx="10676238" cy="1248667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E6DA299-C427-210C-8948-E5B5248B2E63}"/>
              </a:ext>
            </a:extLst>
          </p:cNvPr>
          <p:cNvSpPr txBox="1"/>
          <p:nvPr/>
        </p:nvSpPr>
        <p:spPr>
          <a:xfrm>
            <a:off x="497920" y="13015218"/>
            <a:ext cx="9680398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JP" altLang="ja-JP" sz="2000" dirty="0">
                <a:latin typeface="Cambria" panose="02040503050406030204" pitchFamily="18" charset="0"/>
                <a:ea typeface="Cambria" panose="02040503050406030204" pitchFamily="18" charset="0"/>
              </a:rPr>
              <a:t>Supplementary Figure </a:t>
            </a:r>
            <a:r>
              <a:rPr lang="en-GB" altLang="ja-JP" sz="2000" dirty="0">
                <a:latin typeface="Cambria" panose="02040503050406030204" pitchFamily="18" charset="0"/>
                <a:ea typeface="Cambria" panose="02040503050406030204" pitchFamily="18" charset="0"/>
              </a:rPr>
              <a:t>4</a:t>
            </a:r>
            <a:r>
              <a:rPr lang="en-JP" altLang="ja-JP" sz="2000" dirty="0">
                <a:latin typeface="Cambria" panose="02040503050406030204" pitchFamily="18" charset="0"/>
                <a:ea typeface="Cambria" panose="02040503050406030204" pitchFamily="18" charset="0"/>
              </a:rPr>
              <a:t>: </a:t>
            </a:r>
            <a:r>
              <a:rPr lang="en-US" altLang="ja-JP" sz="2000" dirty="0">
                <a:latin typeface="Cambria" panose="02040503050406030204" pitchFamily="18" charset="0"/>
                <a:ea typeface="Cambria" panose="02040503050406030204" pitchFamily="18" charset="0"/>
              </a:rPr>
              <a:t>Forest plot showing meta-analysis of anti-HEV IgG prevalence among the low-risk groups of acquiring HEV among the</a:t>
            </a:r>
            <a:r>
              <a:rPr lang="en-GB" altLang="ja-JP" sz="2000" dirty="0">
                <a:latin typeface="Cambria" panose="02040503050406030204" pitchFamily="18" charset="0"/>
                <a:ea typeface="Cambria" panose="02040503050406030204" pitchFamily="18" charset="0"/>
              </a:rPr>
              <a:t> population of Southeast Asia.</a:t>
            </a:r>
            <a:endParaRPr lang="en-JP" altLang="ja-JP" sz="2000" dirty="0"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3834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12E5E7D-5DDE-4E4C-A423-EAFA23B2C18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065" t="26942" r="8365" b="28166"/>
          <a:stretch/>
        </p:blipFill>
        <p:spPr>
          <a:xfrm>
            <a:off x="0" y="2032997"/>
            <a:ext cx="10825506" cy="775355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E561D9E-BA9F-E919-D75C-0FEA3229D191}"/>
              </a:ext>
            </a:extLst>
          </p:cNvPr>
          <p:cNvSpPr txBox="1"/>
          <p:nvPr/>
        </p:nvSpPr>
        <p:spPr>
          <a:xfrm>
            <a:off x="466067" y="10248245"/>
            <a:ext cx="981475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Supplementary Figure 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5</a:t>
            </a:r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: </a:t>
            </a:r>
            <a:r>
              <a:rPr lang="en-US" sz="2000" dirty="0">
                <a:latin typeface="Cambria" panose="02040503050406030204" pitchFamily="18" charset="0"/>
                <a:ea typeface="Cambria" panose="02040503050406030204" pitchFamily="18" charset="0"/>
              </a:rPr>
              <a:t>Forest plot showing meta-analysis of anti-HEV IgG prevalence among the high-risk groups of acquiring HEV among the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 population of Southeast Asia.</a:t>
            </a:r>
            <a:endParaRPr lang="en-JP" sz="2000" dirty="0"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08193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C848E22-AA6A-7BD8-E96E-66781A8EBF5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908" b="9889"/>
          <a:stretch/>
        </p:blipFill>
        <p:spPr>
          <a:xfrm>
            <a:off x="-1" y="1062181"/>
            <a:ext cx="10769603" cy="1136871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7337E54-406E-1022-2BC0-8E89CFAD1948}"/>
              </a:ext>
            </a:extLst>
          </p:cNvPr>
          <p:cNvSpPr txBox="1"/>
          <p:nvPr/>
        </p:nvSpPr>
        <p:spPr>
          <a:xfrm>
            <a:off x="395416" y="12735134"/>
            <a:ext cx="988540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Supplementary Figure 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6</a:t>
            </a:r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: 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F</a:t>
            </a:r>
            <a:r>
              <a:rPr lang="en-US" sz="2000" dirty="0">
                <a:latin typeface="Cambria" panose="02040503050406030204" pitchFamily="18" charset="0"/>
                <a:ea typeface="Cambria" panose="02040503050406030204" pitchFamily="18" charset="0"/>
              </a:rPr>
              <a:t>orest plot showing meta-analysis of anti-HEV IgM prevalence by countries of 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Southeast Asia, with authors, years of study, and study population type. </a:t>
            </a:r>
            <a:endParaRPr lang="en-JP" sz="2000" dirty="0"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53112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0E6FF80-F46F-72F1-3CBF-D5F133D252D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047" t="7377" r="7712" b="7831"/>
          <a:stretch/>
        </p:blipFill>
        <p:spPr>
          <a:xfrm>
            <a:off x="296540" y="456077"/>
            <a:ext cx="10206682" cy="1218363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8348111-864C-E8B2-B46C-5F0D0BC2A0C9}"/>
              </a:ext>
            </a:extLst>
          </p:cNvPr>
          <p:cNvSpPr txBox="1"/>
          <p:nvPr/>
        </p:nvSpPr>
        <p:spPr>
          <a:xfrm>
            <a:off x="533150" y="13041023"/>
            <a:ext cx="966117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Supplementary Figure 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7</a:t>
            </a:r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: 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Forest</a:t>
            </a:r>
            <a:r>
              <a:rPr lang="en-US" sz="2000" dirty="0">
                <a:latin typeface="Cambria" panose="02040503050406030204" pitchFamily="18" charset="0"/>
                <a:ea typeface="Cambria" panose="02040503050406030204" pitchFamily="18" charset="0"/>
              </a:rPr>
              <a:t> plot showing meta-analysis of anti-HEV IgM prevalence by the 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study population in Southeast Asia.</a:t>
            </a:r>
            <a:endParaRPr lang="en-JP" sz="2000" dirty="0"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966999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143365B-CC4A-EE37-ED5E-A28FF361657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875" t="22196" r="7380" b="26024"/>
          <a:stretch/>
        </p:blipFill>
        <p:spPr>
          <a:xfrm>
            <a:off x="0" y="3067689"/>
            <a:ext cx="10798020" cy="543376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55616F9-C975-3438-463A-7E17D188B7AA}"/>
              </a:ext>
            </a:extLst>
          </p:cNvPr>
          <p:cNvSpPr txBox="1"/>
          <p:nvPr/>
        </p:nvSpPr>
        <p:spPr>
          <a:xfrm>
            <a:off x="390122" y="8763687"/>
            <a:ext cx="1001951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Supplementary Figure 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8</a:t>
            </a:r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: </a:t>
            </a:r>
            <a:r>
              <a:rPr lang="en-US" sz="2000" dirty="0">
                <a:latin typeface="Cambria" panose="02040503050406030204" pitchFamily="18" charset="0"/>
                <a:ea typeface="Cambria" panose="02040503050406030204" pitchFamily="18" charset="0"/>
              </a:rPr>
              <a:t>Forest plot showing meta-analysis of anti-HEV IgM prevalence among the high-risk groups of acquiring HEV among the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 population in Southeast Asia.</a:t>
            </a:r>
            <a:endParaRPr lang="en-JP" sz="2000" dirty="0"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025408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2E5A8FA-3027-D2FD-E857-C2853DEEE02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9005" b="10153"/>
          <a:stretch/>
        </p:blipFill>
        <p:spPr>
          <a:xfrm>
            <a:off x="0" y="1496291"/>
            <a:ext cx="10799763" cy="1047689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DAEB917-E5BC-0D62-5A66-84F888D2D2A0}"/>
              </a:ext>
            </a:extLst>
          </p:cNvPr>
          <p:cNvSpPr txBox="1"/>
          <p:nvPr/>
        </p:nvSpPr>
        <p:spPr>
          <a:xfrm>
            <a:off x="329208" y="12331806"/>
            <a:ext cx="998868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Supplementary Figure 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9</a:t>
            </a:r>
            <a:r>
              <a:rPr lang="en-JP" sz="2000" dirty="0">
                <a:latin typeface="Cambria" panose="02040503050406030204" pitchFamily="18" charset="0"/>
                <a:ea typeface="Cambria" panose="02040503050406030204" pitchFamily="18" charset="0"/>
              </a:rPr>
              <a:t>: </a:t>
            </a:r>
            <a:r>
              <a:rPr lang="en-US" sz="2000" dirty="0">
                <a:latin typeface="Cambria" panose="02040503050406030204" pitchFamily="18" charset="0"/>
                <a:ea typeface="Cambria" panose="02040503050406030204" pitchFamily="18" charset="0"/>
              </a:rPr>
              <a:t>Forest plot showing meta-analysis of anti-HEV IgM prevalence among the low-risk groups of acquiring HEV among the</a:t>
            </a:r>
            <a:r>
              <a:rPr lang="en-GB" sz="2000" dirty="0">
                <a:latin typeface="Cambria" panose="02040503050406030204" pitchFamily="18" charset="0"/>
                <a:ea typeface="Cambria" panose="02040503050406030204" pitchFamily="18" charset="0"/>
              </a:rPr>
              <a:t> population of Southeast Asia.</a:t>
            </a:r>
            <a:endParaRPr lang="en-JP" sz="2000" dirty="0"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40043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E8FB01A186B15A419F7C4381879886CF" ma:contentTypeVersion="14" ma:contentTypeDescription="新しいドキュメントを作成します。" ma:contentTypeScope="" ma:versionID="43f181d99176202d7b0e6666a628f7da">
  <xsd:schema xmlns:xsd="http://www.w3.org/2001/XMLSchema" xmlns:xs="http://www.w3.org/2001/XMLSchema" xmlns:p="http://schemas.microsoft.com/office/2006/metadata/properties" xmlns:ns3="a92e6355-2011-49fc-a9d7-dcab4f15d6a9" xmlns:ns4="35bbbfce-10ac-49f8-85a6-2eb53df6e0ac" targetNamespace="http://schemas.microsoft.com/office/2006/metadata/properties" ma:root="true" ma:fieldsID="059fa70a0285e0d5f4df058d301bd41d" ns3:_="" ns4:_="">
    <xsd:import namespace="a92e6355-2011-49fc-a9d7-dcab4f15d6a9"/>
    <xsd:import namespace="35bbbfce-10ac-49f8-85a6-2eb53df6e0ac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92e6355-2011-49fc-a9d7-dcab4f15d6a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18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19" nillable="true" ma:displayName="_activity" ma:hidden="true" ma:internalName="_activity">
      <xsd:simpleType>
        <xsd:restriction base="dms:Note"/>
      </xsd:simpleType>
    </xsd:element>
    <xsd:element name="MediaServiceObjectDetectorVersions" ma:index="2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Location" ma:index="21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5bbbfce-10ac-49f8-85a6-2eb53df6e0ac" elementFormDefault="qualified">
    <xsd:import namespace="http://schemas.microsoft.com/office/2006/documentManagement/types"/>
    <xsd:import namespace="http://schemas.microsoft.com/office/infopath/2007/PartnerControls"/>
    <xsd:element name="SharedWithUsers" ma:index="15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7" nillable="true" ma:displayName="共有のヒントのハッシュ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a92e6355-2011-49fc-a9d7-dcab4f15d6a9" xsi:nil="true"/>
  </documentManagement>
</p:properties>
</file>

<file path=customXml/itemProps1.xml><?xml version="1.0" encoding="utf-8"?>
<ds:datastoreItem xmlns:ds="http://schemas.openxmlformats.org/officeDocument/2006/customXml" ds:itemID="{D4CB3823-30C8-4428-A9CE-91CA5744DDA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92e6355-2011-49fc-a9d7-dcab4f15d6a9"/>
    <ds:schemaRef ds:uri="35bbbfce-10ac-49f8-85a6-2eb53df6e0a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5A1260E0-EAC9-4DD4-A8E3-A106E1CA060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B4348B7-E730-4BD1-8D4D-24F296AF0AAA}">
  <ds:schemaRefs>
    <ds:schemaRef ds:uri="http://purl.org/dc/terms/"/>
    <ds:schemaRef ds:uri="a92e6355-2011-49fc-a9d7-dcab4f15d6a9"/>
    <ds:schemaRef ds:uri="http://schemas.microsoft.com/office/2006/documentManagement/types"/>
    <ds:schemaRef ds:uri="35bbbfce-10ac-49f8-85a6-2eb53df6e0ac"/>
    <ds:schemaRef ds:uri="http://purl.org/dc/elements/1.1/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778</TotalTime>
  <Words>379</Words>
  <Application>Microsoft Office PowerPoint</Application>
  <PresentationFormat>Custom</PresentationFormat>
  <Paragraphs>17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8" baseType="lpstr">
      <vt:lpstr>Arial</vt:lpstr>
      <vt:lpstr>Calibri</vt:lpstr>
      <vt:lpstr>Calibri Light</vt:lpstr>
      <vt:lpstr>Cambri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n Un</dc:creator>
  <cp:lastModifiedBy>Vn Un</cp:lastModifiedBy>
  <cp:revision>1</cp:revision>
  <cp:lastPrinted>2023-08-30T01:58:36Z</cp:lastPrinted>
  <dcterms:created xsi:type="dcterms:W3CDTF">2023-08-29T05:18:54Z</dcterms:created>
  <dcterms:modified xsi:type="dcterms:W3CDTF">2023-08-30T10:57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8FB01A186B15A419F7C4381879886CF</vt:lpwstr>
  </property>
</Properties>
</file>